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9" autoAdjust="0"/>
    <p:restoredTop sz="94660"/>
  </p:normalViewPr>
  <p:slideViewPr>
    <p:cSldViewPr snapToGrid="0">
      <p:cViewPr varScale="1">
        <p:scale>
          <a:sx n="83" d="100"/>
          <a:sy n="83" d="100"/>
        </p:scale>
        <p:origin x="48" y="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1668A1F-02B9-484E-AA5C-F562E11AEA4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B24BCA57-66A2-4899-ABC1-11D45A85D7B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ED94D56-8A5C-4488-83B0-1CED059F41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144BFB-7ACB-4314-B5FB-7B66FF932FBE}" type="datetimeFigureOut">
              <a:rPr lang="es-ES" smtClean="0"/>
              <a:t>30/07/2021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8DC5CB3-4395-4FF1-9A83-C951656A77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8144FD1-C872-4DC8-B4CD-3242697863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55D71-4F61-4A15-9F40-20C812B3585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4167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0322FDE-8DE7-43E4-8D70-6BC7C9C31F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84132AE7-D064-4308-ACE7-88B766E7137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B1DABED-89F5-4F29-82C8-B968770754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144BFB-7ACB-4314-B5FB-7B66FF932FBE}" type="datetimeFigureOut">
              <a:rPr lang="es-ES" smtClean="0"/>
              <a:t>30/07/2021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018A1D2-29ED-4351-ADFD-7CCDD87A16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2DC9438-9AD9-475E-AAF2-FEA68DBAD4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55D71-4F61-4A15-9F40-20C812B3585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531674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731FC3D4-1D8C-4B7B-982D-49EDB5E95B5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387C70E7-5556-455B-9CA2-667372D720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CAB0148-6401-49F4-8D8C-39E3C7353B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144BFB-7ACB-4314-B5FB-7B66FF932FBE}" type="datetimeFigureOut">
              <a:rPr lang="es-ES" smtClean="0"/>
              <a:t>30/07/2021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215D23B-39F4-48AB-91B3-0436F16B7E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E39C075-8B61-4F23-A0EA-6EDEA10615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55D71-4F61-4A15-9F40-20C812B3585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058468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270A1A2-F3B8-41B8-9F3E-EEF1F240BD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6D49E341-CF10-45EB-BAC0-9A5675CC20D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D68CE94-EBC1-4E78-9CE9-7AB19FEEFA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144BFB-7ACB-4314-B5FB-7B66FF932FBE}" type="datetimeFigureOut">
              <a:rPr lang="es-ES" smtClean="0"/>
              <a:t>30/07/2021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AA0DC97-77C1-4E1E-84BA-3FB5A9532C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9951D23-6099-41E0-B4A9-351E73B2A2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55D71-4F61-4A15-9F40-20C812B3585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880650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D18AD47-1E17-409D-9249-324274A8A5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833B1502-A039-4BFE-845E-4BDF127579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12F40D3-45FC-4218-813D-E3F8A0522B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144BFB-7ACB-4314-B5FB-7B66FF932FBE}" type="datetimeFigureOut">
              <a:rPr lang="es-ES" smtClean="0"/>
              <a:t>30/07/2021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CB38038-EC3A-4930-A632-60BA6C7A80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922BB1D-53AF-462E-89A2-D42BE26A87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55D71-4F61-4A15-9F40-20C812B3585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820226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A4029EF-A6BD-4E5F-A4C0-257F966561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77682D2F-CBED-47FE-9879-B8C4627231F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4E3FBB86-F836-4595-91A6-AE7A65B6DA9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F7FB286B-DD54-4325-9301-6E44143281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144BFB-7ACB-4314-B5FB-7B66FF932FBE}" type="datetimeFigureOut">
              <a:rPr lang="es-ES" smtClean="0"/>
              <a:t>30/07/2021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E609BCDF-4F62-4EAD-93D2-B4613A6E8C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6E6A9217-9349-45B6-BA73-4969CC216A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55D71-4F61-4A15-9F40-20C812B3585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860509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0CB873A-5845-46B0-BEE1-DAFDDA17D2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75EA2D81-0AC1-47DB-8238-3999BA26AC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6EA448E5-33CF-4298-B009-CBDE08EA283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156A5D64-8E65-4A83-9056-FC537ABBEE4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4C5549D6-A02D-497E-AC56-46A7A542AD0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104C25FF-6E6A-451A-9E8A-B84142C66C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144BFB-7ACB-4314-B5FB-7B66FF932FBE}" type="datetimeFigureOut">
              <a:rPr lang="es-ES" smtClean="0"/>
              <a:t>30/07/2021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80387AB4-CA3F-4535-93B2-8019F8948E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382E5162-B633-463C-A764-4B2E8AD2A5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55D71-4F61-4A15-9F40-20C812B3585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253214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069EB35-5CE6-4F71-AF4E-C2CDAF2CB0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9FDACE39-5AB4-452C-8876-7F8464865E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144BFB-7ACB-4314-B5FB-7B66FF932FBE}" type="datetimeFigureOut">
              <a:rPr lang="es-ES" smtClean="0"/>
              <a:t>30/07/2021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99837A39-77EC-4FF8-ADCB-DE56249B33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04A827EB-67A4-49FD-A22E-FF071D11DF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55D71-4F61-4A15-9F40-20C812B3585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76181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AAA04773-7045-46F6-A0BD-BB1DB99ABA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144BFB-7ACB-4314-B5FB-7B66FF932FBE}" type="datetimeFigureOut">
              <a:rPr lang="es-ES" smtClean="0"/>
              <a:t>30/07/2021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2A1522B4-EDF1-4EE1-8321-5488E8A74E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1394D047-C919-4B05-9F6D-5BE93D2FE7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55D71-4F61-4A15-9F40-20C812B3585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195933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390291E-3010-4A92-BAC5-53EEBF4B21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0972140B-0F62-4D9F-B0B9-B6522675203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60E7E119-BC54-4F82-B4B5-512245FF3B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AABC171F-1B5D-4E99-BB3A-85B13DE77C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144BFB-7ACB-4314-B5FB-7B66FF932FBE}" type="datetimeFigureOut">
              <a:rPr lang="es-ES" smtClean="0"/>
              <a:t>30/07/2021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F9DD61D4-B7DF-49E0-B4B0-2AF3DD214D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3A157B19-C1EE-49CD-A7C2-26AC44A87F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55D71-4F61-4A15-9F40-20C812B3585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45213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46A2CD4-01F0-4B4E-8A74-4BC4034BF8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208AD073-F70E-437F-AB1E-F0514F89607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BCDBE3A3-1C44-4D59-9E13-8BC252EBA34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78D0F01C-EFE8-4D0B-97F6-E63C43B693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144BFB-7ACB-4314-B5FB-7B66FF932FBE}" type="datetimeFigureOut">
              <a:rPr lang="es-ES" smtClean="0"/>
              <a:t>30/07/2021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6C9FC1AE-0D84-45D8-8412-398EDF819B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E95BA11D-118E-45E1-B908-D8D6E4904A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55D71-4F61-4A15-9F40-20C812B3585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499310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56087C51-EC18-477E-AF90-54B10764DC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D056B903-8D0C-4D2E-B723-25B2095B9D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71EC134-F14F-4875-9C83-004C71A8306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144BFB-7ACB-4314-B5FB-7B66FF932FBE}" type="datetimeFigureOut">
              <a:rPr lang="es-ES" smtClean="0"/>
              <a:t>30/07/2021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61DA6F2-0BB3-4D30-9F31-570AD5CE485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29DE4D8-6C75-4A14-9275-A772483E863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A55D71-4F61-4A15-9F40-20C812B3585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33781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">
            <a:extLst>
              <a:ext uri="{FF2B5EF4-FFF2-40B4-BE49-F238E27FC236}">
                <a16:creationId xmlns:a16="http://schemas.microsoft.com/office/drawing/2014/main" id="{77F19632-732E-4E34-9723-3A1A76CD33E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70846" y="1430253"/>
            <a:ext cx="1887538" cy="1243013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ES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cords</a:t>
            </a:r>
            <a:r>
              <a:rPr lang="es-E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dentified</a:t>
            </a:r>
            <a:r>
              <a:rPr lang="es-E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rough</a:t>
            </a:r>
            <a:r>
              <a:rPr lang="es-E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tabase</a:t>
            </a:r>
            <a:r>
              <a:rPr lang="es-E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arching</a:t>
            </a:r>
            <a:r>
              <a:rPr lang="es-E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AU" altLang="es-E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n = 753)</a:t>
            </a:r>
          </a:p>
        </p:txBody>
      </p:sp>
      <p:sp>
        <p:nvSpPr>
          <p:cNvPr id="5" name="Rectangle 2">
            <a:extLst>
              <a:ext uri="{FF2B5EF4-FFF2-40B4-BE49-F238E27FC236}">
                <a16:creationId xmlns:a16="http://schemas.microsoft.com/office/drawing/2014/main" id="{09575B6C-30A1-4850-9347-3736C2B6AF1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52092" y="1543068"/>
            <a:ext cx="2750526" cy="800388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s-E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cords removed </a:t>
            </a:r>
            <a:r>
              <a:rPr kumimoji="0" lang="en-AU" altLang="es-ES" sz="1000" b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efore screening</a:t>
            </a:r>
            <a:r>
              <a:rPr lang="en-AU" altLang="es-ES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n = 260)</a:t>
            </a:r>
            <a:endParaRPr kumimoji="0" lang="en-AU" altLang="es-E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s-E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 Duplicate records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AU" altLang="es-E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 Letters / Case reports</a:t>
            </a:r>
          </a:p>
        </p:txBody>
      </p:sp>
      <p:sp>
        <p:nvSpPr>
          <p:cNvPr id="6" name="Rectangle 3">
            <a:extLst>
              <a:ext uri="{FF2B5EF4-FFF2-40B4-BE49-F238E27FC236}">
                <a16:creationId xmlns:a16="http://schemas.microsoft.com/office/drawing/2014/main" id="{684980C4-F893-4A4D-AA7C-B2580B66884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70846" y="3051091"/>
            <a:ext cx="1887538" cy="527050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ES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udies</a:t>
            </a:r>
            <a:r>
              <a:rPr lang="es-E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ad</a:t>
            </a:r>
            <a:r>
              <a:rPr lang="es-E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es-E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reening</a:t>
            </a:r>
            <a:endParaRPr lang="es-ES" sz="10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R="0" lvl="0" indent="0"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AU" altLang="es-E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n = 493)</a:t>
            </a:r>
          </a:p>
        </p:txBody>
      </p:sp>
      <p:sp>
        <p:nvSpPr>
          <p:cNvPr id="7" name="Rectangle 4">
            <a:extLst>
              <a:ext uri="{FF2B5EF4-FFF2-40B4-BE49-F238E27FC236}">
                <a16:creationId xmlns:a16="http://schemas.microsoft.com/office/drawing/2014/main" id="{C96AFF33-8642-429E-BC0D-04772FAC619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60037" y="2465419"/>
            <a:ext cx="2742581" cy="1389801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s-E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cords excluded (n = 445)</a:t>
            </a:r>
          </a:p>
          <a:p>
            <a:pPr marR="0" lvl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r>
              <a:rPr kumimoji="0" lang="en-AU" altLang="es-E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- Uncontrolled trials</a:t>
            </a:r>
            <a:endParaRPr lang="en-AU" altLang="es-ES" sz="10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AU" altLang="es-E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- Non-randomized trials</a:t>
            </a: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AU" altLang="es-E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 Single arm trials</a:t>
            </a:r>
            <a:endParaRPr kumimoji="0" lang="en-AU" altLang="es-ES" sz="10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AU" altLang="es-E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 Multiple drug combinations</a:t>
            </a: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AU" altLang="es-E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 Botanical products or antioxidants</a:t>
            </a: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AU" altLang="es-E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 Lifestyle intervention</a:t>
            </a: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AU" altLang="es-E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- Pediatric population</a:t>
            </a:r>
            <a:endParaRPr lang="en-AU" altLang="es-ES" sz="10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tangle 5">
            <a:extLst>
              <a:ext uri="{FF2B5EF4-FFF2-40B4-BE49-F238E27FC236}">
                <a16:creationId xmlns:a16="http://schemas.microsoft.com/office/drawing/2014/main" id="{58EE8700-3F1D-48EB-9B6D-2721E7E200C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72434" y="3925803"/>
            <a:ext cx="1887537" cy="527050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E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ull-</a:t>
            </a:r>
            <a:r>
              <a:rPr lang="es-ES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xt</a:t>
            </a:r>
            <a:r>
              <a:rPr lang="es-E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rticles</a:t>
            </a:r>
            <a:r>
              <a:rPr lang="es-E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sessed</a:t>
            </a:r>
            <a:r>
              <a:rPr lang="es-E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es-E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ligibility</a:t>
            </a:r>
            <a:r>
              <a:rPr lang="es-E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n = 48)</a:t>
            </a:r>
          </a:p>
        </p:txBody>
      </p:sp>
      <p:sp>
        <p:nvSpPr>
          <p:cNvPr id="9" name="Rectangle 6">
            <a:extLst>
              <a:ext uri="{FF2B5EF4-FFF2-40B4-BE49-F238E27FC236}">
                <a16:creationId xmlns:a16="http://schemas.microsoft.com/office/drawing/2014/main" id="{8ED60BEB-20C5-4133-8342-37EC9D1430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61633" y="3963524"/>
            <a:ext cx="2740969" cy="800388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s-E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orts </a:t>
            </a:r>
            <a:r>
              <a:rPr kumimoji="0" lang="en-AU" altLang="es-ES" sz="10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xcuded</a:t>
            </a:r>
            <a:r>
              <a:rPr kumimoji="0" lang="en-AU" altLang="es-E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n = 21)</a:t>
            </a: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AU" altLang="es-E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 No paired liver biopsy</a:t>
            </a: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AU" altLang="es-E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 Phase I or Phase IV</a:t>
            </a:r>
          </a:p>
        </p:txBody>
      </p:sp>
      <p:sp>
        <p:nvSpPr>
          <p:cNvPr id="12" name="Rectangle 13">
            <a:extLst>
              <a:ext uri="{FF2B5EF4-FFF2-40B4-BE49-F238E27FC236}">
                <a16:creationId xmlns:a16="http://schemas.microsoft.com/office/drawing/2014/main" id="{C151830F-1B2F-498C-BC44-13D142BABFB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51796" y="4773438"/>
            <a:ext cx="1887538" cy="823795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s-E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tudies included in </a:t>
            </a:r>
            <a:r>
              <a:rPr lang="en-AU" altLang="es-ES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meta-analysis </a:t>
            </a:r>
            <a:r>
              <a:rPr kumimoji="0" lang="en-AU" altLang="es-E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n = </a:t>
            </a:r>
            <a:r>
              <a:rPr lang="en-AU" altLang="es-ES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7</a:t>
            </a:r>
            <a:r>
              <a:rPr kumimoji="0" lang="en-AU" altLang="es-E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endParaRPr kumimoji="0" lang="es-ES" altLang="es-E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cxnSp>
        <p:nvCxnSpPr>
          <p:cNvPr id="13" name="Straight Arrow Connector 14">
            <a:extLst>
              <a:ext uri="{FF2B5EF4-FFF2-40B4-BE49-F238E27FC236}">
                <a16:creationId xmlns:a16="http://schemas.microsoft.com/office/drawing/2014/main" id="{762CC84E-6D1E-4F76-94F0-6D8A0D877E9C}"/>
              </a:ext>
            </a:extLst>
          </p:cNvPr>
          <p:cNvCxnSpPr/>
          <p:nvPr/>
        </p:nvCxnSpPr>
        <p:spPr>
          <a:xfrm>
            <a:off x="6061069" y="2054174"/>
            <a:ext cx="56324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5">
            <a:extLst>
              <a:ext uri="{FF2B5EF4-FFF2-40B4-BE49-F238E27FC236}">
                <a16:creationId xmlns:a16="http://schemas.microsoft.com/office/drawing/2014/main" id="{5866AD85-83D9-4F31-BC7F-7874AC038A50}"/>
              </a:ext>
            </a:extLst>
          </p:cNvPr>
          <p:cNvCxnSpPr/>
          <p:nvPr/>
        </p:nvCxnSpPr>
        <p:spPr>
          <a:xfrm>
            <a:off x="6061069" y="3327348"/>
            <a:ext cx="56324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6">
            <a:extLst>
              <a:ext uri="{FF2B5EF4-FFF2-40B4-BE49-F238E27FC236}">
                <a16:creationId xmlns:a16="http://schemas.microsoft.com/office/drawing/2014/main" id="{F1164335-F4EF-4E03-85A8-F00B44AD0F1A}"/>
              </a:ext>
            </a:extLst>
          </p:cNvPr>
          <p:cNvCxnSpPr/>
          <p:nvPr/>
        </p:nvCxnSpPr>
        <p:spPr>
          <a:xfrm>
            <a:off x="6061358" y="4199606"/>
            <a:ext cx="56324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Flowchart: Alternate Process 29">
            <a:extLst>
              <a:ext uri="{FF2B5EF4-FFF2-40B4-BE49-F238E27FC236}">
                <a16:creationId xmlns:a16="http://schemas.microsoft.com/office/drawing/2014/main" id="{B28F7943-15C4-4698-A9E9-883F51E054B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78784" y="998398"/>
            <a:ext cx="5223818" cy="301254"/>
          </a:xfrm>
          <a:prstGeom prst="flowChartAlternateProcess">
            <a:avLst/>
          </a:prstGeom>
          <a:solidFill>
            <a:srgbClr val="FFC000"/>
          </a:solidFill>
          <a:ln w="12700">
            <a:solidFill>
              <a:srgbClr val="7F5F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s-E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dentification of studies via databases and registers</a:t>
            </a:r>
            <a:endParaRPr kumimoji="0" lang="en-AU" altLang="es-ES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8" name="Flowchart: Alternate Process 31">
            <a:extLst>
              <a:ext uri="{FF2B5EF4-FFF2-40B4-BE49-F238E27FC236}">
                <a16:creationId xmlns:a16="http://schemas.microsoft.com/office/drawing/2014/main" id="{4305E773-5852-416B-9CE2-D0AE458CF3EE}"/>
              </a:ext>
            </a:extLst>
          </p:cNvPr>
          <p:cNvSpPr>
            <a:spLocks noChangeArrowheads="1"/>
          </p:cNvSpPr>
          <p:nvPr/>
        </p:nvSpPr>
        <p:spPr bwMode="auto">
          <a:xfrm rot="-5400000">
            <a:off x="3208822" y="1935078"/>
            <a:ext cx="1276350" cy="263525"/>
          </a:xfrm>
          <a:prstGeom prst="flowChartAlternateProcess">
            <a:avLst/>
          </a:prstGeom>
          <a:solidFill>
            <a:srgbClr val="9CC2E5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s-E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dentification</a:t>
            </a:r>
            <a:endParaRPr kumimoji="0" lang="en-AU" altLang="es-ES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9" name="Flowchart: Alternate Process 32">
            <a:extLst>
              <a:ext uri="{FF2B5EF4-FFF2-40B4-BE49-F238E27FC236}">
                <a16:creationId xmlns:a16="http://schemas.microsoft.com/office/drawing/2014/main" id="{1E57F38C-34A4-4F62-82F7-9AE17BACD28B}"/>
              </a:ext>
            </a:extLst>
          </p:cNvPr>
          <p:cNvSpPr>
            <a:spLocks noChangeArrowheads="1"/>
          </p:cNvSpPr>
          <p:nvPr/>
        </p:nvSpPr>
        <p:spPr bwMode="auto">
          <a:xfrm rot="-5400000">
            <a:off x="3143731" y="3636883"/>
            <a:ext cx="1420813" cy="249228"/>
          </a:xfrm>
          <a:prstGeom prst="flowChartAlternateProcess">
            <a:avLst/>
          </a:prstGeom>
          <a:solidFill>
            <a:srgbClr val="9CC2E5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s-E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creening</a:t>
            </a:r>
            <a:endParaRPr kumimoji="0" lang="en-AU" altLang="es-E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0" name="Flowchart: Alternate Process 33">
            <a:extLst>
              <a:ext uri="{FF2B5EF4-FFF2-40B4-BE49-F238E27FC236}">
                <a16:creationId xmlns:a16="http://schemas.microsoft.com/office/drawing/2014/main" id="{CE65086C-0257-43D2-B86E-FAFED2AA4CE1}"/>
              </a:ext>
            </a:extLst>
          </p:cNvPr>
          <p:cNvSpPr>
            <a:spLocks noChangeArrowheads="1"/>
          </p:cNvSpPr>
          <p:nvPr/>
        </p:nvSpPr>
        <p:spPr bwMode="auto">
          <a:xfrm rot="-5400000">
            <a:off x="3437475" y="5055958"/>
            <a:ext cx="833322" cy="249229"/>
          </a:xfrm>
          <a:prstGeom prst="flowChartAlternateProcess">
            <a:avLst/>
          </a:prstGeom>
          <a:solidFill>
            <a:srgbClr val="9CC2E5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s-E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cluded</a:t>
            </a:r>
            <a:endParaRPr kumimoji="0" lang="en-AU" altLang="es-ES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cxnSp>
        <p:nvCxnSpPr>
          <p:cNvPr id="21" name="Straight Arrow Connector 27">
            <a:extLst>
              <a:ext uri="{FF2B5EF4-FFF2-40B4-BE49-F238E27FC236}">
                <a16:creationId xmlns:a16="http://schemas.microsoft.com/office/drawing/2014/main" id="{002BC091-C366-4191-94D8-803A36F10FDF}"/>
              </a:ext>
            </a:extLst>
          </p:cNvPr>
          <p:cNvCxnSpPr/>
          <p:nvPr/>
        </p:nvCxnSpPr>
        <p:spPr>
          <a:xfrm>
            <a:off x="5136908" y="2685365"/>
            <a:ext cx="0" cy="28130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35">
            <a:extLst>
              <a:ext uri="{FF2B5EF4-FFF2-40B4-BE49-F238E27FC236}">
                <a16:creationId xmlns:a16="http://schemas.microsoft.com/office/drawing/2014/main" id="{E76DDFC7-B1CA-4228-B0A4-F29911DDF4C3}"/>
              </a:ext>
            </a:extLst>
          </p:cNvPr>
          <p:cNvCxnSpPr/>
          <p:nvPr/>
        </p:nvCxnSpPr>
        <p:spPr>
          <a:xfrm>
            <a:off x="5136908" y="3582215"/>
            <a:ext cx="0" cy="28130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36">
            <a:extLst>
              <a:ext uri="{FF2B5EF4-FFF2-40B4-BE49-F238E27FC236}">
                <a16:creationId xmlns:a16="http://schemas.microsoft.com/office/drawing/2014/main" id="{A81BB4EB-C178-42B8-BA71-859C2D896C5D}"/>
              </a:ext>
            </a:extLst>
          </p:cNvPr>
          <p:cNvCxnSpPr/>
          <p:nvPr/>
        </p:nvCxnSpPr>
        <p:spPr>
          <a:xfrm>
            <a:off x="5146433" y="4456492"/>
            <a:ext cx="0" cy="28130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Rectangle 22">
            <a:extLst>
              <a:ext uri="{FF2B5EF4-FFF2-40B4-BE49-F238E27FC236}">
                <a16:creationId xmlns:a16="http://schemas.microsoft.com/office/drawing/2014/main" id="{48765D93-99DF-488D-AD7A-7EEE6F988D1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56264" y="-79899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s-ES"/>
          </a:p>
        </p:txBody>
      </p:sp>
      <p:cxnSp>
        <p:nvCxnSpPr>
          <p:cNvPr id="3" name="Conector: angular 2">
            <a:extLst>
              <a:ext uri="{FF2B5EF4-FFF2-40B4-BE49-F238E27FC236}">
                <a16:creationId xmlns:a16="http://schemas.microsoft.com/office/drawing/2014/main" id="{85319CE5-7F53-49D2-A796-1A0EF4D1AE98}"/>
              </a:ext>
            </a:extLst>
          </p:cNvPr>
          <p:cNvCxnSpPr>
            <a:cxnSpLocks/>
            <a:stCxn id="12" idx="3"/>
            <a:endCxn id="26" idx="1"/>
          </p:cNvCxnSpPr>
          <p:nvPr/>
        </p:nvCxnSpPr>
        <p:spPr>
          <a:xfrm>
            <a:off x="6039334" y="5185336"/>
            <a:ext cx="620703" cy="129597"/>
          </a:xfrm>
          <a:prstGeom prst="bentConnector3">
            <a:avLst>
              <a:gd name="adj1" fmla="val 50000"/>
            </a:avLst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Rectangle 13">
            <a:extLst>
              <a:ext uri="{FF2B5EF4-FFF2-40B4-BE49-F238E27FC236}">
                <a16:creationId xmlns:a16="http://schemas.microsoft.com/office/drawing/2014/main" id="{DE12282F-01DF-48F6-8361-6ECF9A1E665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60037" y="5119164"/>
            <a:ext cx="1543514" cy="391538"/>
          </a:xfrm>
          <a:prstGeom prst="rect">
            <a:avLst/>
          </a:prstGeom>
          <a:noFill/>
          <a:ln w="12700">
            <a:solidFill>
              <a:srgbClr val="000000"/>
            </a:solidFill>
            <a:prstDash val="dashDot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AU" altLang="es-ES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ublished articles (n = 22)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s-ES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ral presentations (n = 5)</a:t>
            </a:r>
            <a:endParaRPr kumimoji="0" lang="es-ES" altLang="es-ES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24936445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2</TotalTime>
  <Words>130</Words>
  <Application>Microsoft Office PowerPoint</Application>
  <PresentationFormat>Panorámica</PresentationFormat>
  <Paragraphs>25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AVIER AMPUERO HERROJO</dc:creator>
  <cp:lastModifiedBy>JAVIER AMPUERO HERROJO</cp:lastModifiedBy>
  <cp:revision>29</cp:revision>
  <dcterms:created xsi:type="dcterms:W3CDTF">2021-07-25T12:15:37Z</dcterms:created>
  <dcterms:modified xsi:type="dcterms:W3CDTF">2021-07-30T18:46:00Z</dcterms:modified>
</cp:coreProperties>
</file>